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7772400" cy="9144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5"/>
    <p:restoredTop sz="96197"/>
  </p:normalViewPr>
  <p:slideViewPr>
    <p:cSldViewPr snapToGrid="0" snapToObjects="1">
      <p:cViewPr varScale="1">
        <p:scale>
          <a:sx n="93" d="100"/>
          <a:sy n="93" d="100"/>
        </p:scale>
        <p:origin x="2456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496484"/>
            <a:ext cx="6606540" cy="3183467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4802717"/>
            <a:ext cx="5829300" cy="2207683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AE3613-78A9-BB4B-93A1-BA9B229A114A}" type="datetimeFigureOut">
              <a:rPr lang="en-US" smtClean="0"/>
              <a:t>2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E2CDC-A36D-FD4B-8336-0AD9CF2E2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14056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AE3613-78A9-BB4B-93A1-BA9B229A114A}" type="datetimeFigureOut">
              <a:rPr lang="en-US" smtClean="0"/>
              <a:t>2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E2CDC-A36D-FD4B-8336-0AD9CF2E2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95316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486834"/>
            <a:ext cx="1675924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486834"/>
            <a:ext cx="4930616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AE3613-78A9-BB4B-93A1-BA9B229A114A}" type="datetimeFigureOut">
              <a:rPr lang="en-US" smtClean="0"/>
              <a:t>2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E2CDC-A36D-FD4B-8336-0AD9CF2E2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96192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AE3613-78A9-BB4B-93A1-BA9B229A114A}" type="datetimeFigureOut">
              <a:rPr lang="en-US" smtClean="0"/>
              <a:t>2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E2CDC-A36D-FD4B-8336-0AD9CF2E2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83131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279653"/>
            <a:ext cx="6703695" cy="3803649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119286"/>
            <a:ext cx="6703695" cy="2000249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AE3613-78A9-BB4B-93A1-BA9B229A114A}" type="datetimeFigureOut">
              <a:rPr lang="en-US" smtClean="0"/>
              <a:t>2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E2CDC-A36D-FD4B-8336-0AD9CF2E2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82205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434167"/>
            <a:ext cx="330327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434167"/>
            <a:ext cx="330327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AE3613-78A9-BB4B-93A1-BA9B229A114A}" type="datetimeFigureOut">
              <a:rPr lang="en-US" smtClean="0"/>
              <a:t>2/21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E2CDC-A36D-FD4B-8336-0AD9CF2E2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93165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486836"/>
            <a:ext cx="670369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241551"/>
            <a:ext cx="3288089" cy="1098549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340100"/>
            <a:ext cx="3288089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241551"/>
            <a:ext cx="3304282" cy="1098549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340100"/>
            <a:ext cx="3304282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AE3613-78A9-BB4B-93A1-BA9B229A114A}" type="datetimeFigureOut">
              <a:rPr lang="en-US" smtClean="0"/>
              <a:t>2/21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E2CDC-A36D-FD4B-8336-0AD9CF2E2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03578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AE3613-78A9-BB4B-93A1-BA9B229A114A}" type="datetimeFigureOut">
              <a:rPr lang="en-US" smtClean="0"/>
              <a:t>2/21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E2CDC-A36D-FD4B-8336-0AD9CF2E2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8093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AE3613-78A9-BB4B-93A1-BA9B229A114A}" type="datetimeFigureOut">
              <a:rPr lang="en-US" smtClean="0"/>
              <a:t>2/21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E2CDC-A36D-FD4B-8336-0AD9CF2E2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01028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09600"/>
            <a:ext cx="2506801" cy="213360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316569"/>
            <a:ext cx="3934778" cy="6498167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2743200"/>
            <a:ext cx="2506801" cy="5082117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AE3613-78A9-BB4B-93A1-BA9B229A114A}" type="datetimeFigureOut">
              <a:rPr lang="en-US" smtClean="0"/>
              <a:t>2/21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E2CDC-A36D-FD4B-8336-0AD9CF2E2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48075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09600"/>
            <a:ext cx="2506801" cy="213360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316569"/>
            <a:ext cx="3934778" cy="6498167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2743200"/>
            <a:ext cx="2506801" cy="5082117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AE3613-78A9-BB4B-93A1-BA9B229A114A}" type="datetimeFigureOut">
              <a:rPr lang="en-US" smtClean="0"/>
              <a:t>2/21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E2CDC-A36D-FD4B-8336-0AD9CF2E2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80650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486836"/>
            <a:ext cx="670369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434167"/>
            <a:ext cx="670369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8475136"/>
            <a:ext cx="174879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AE3613-78A9-BB4B-93A1-BA9B229A114A}" type="datetimeFigureOut">
              <a:rPr lang="en-US" smtClean="0"/>
              <a:t>2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8475136"/>
            <a:ext cx="262318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8475136"/>
            <a:ext cx="174879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E2CDC-A36D-FD4B-8336-0AD9CF2E2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47102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>
            <a:extLst>
              <a:ext uri="{FF2B5EF4-FFF2-40B4-BE49-F238E27FC236}">
                <a16:creationId xmlns:a16="http://schemas.microsoft.com/office/drawing/2014/main" id="{1CA643A0-4E0B-F647-A768-252E6B9ED012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86" t="960" r="1886" b="-960"/>
          <a:stretch/>
        </p:blipFill>
        <p:spPr bwMode="auto">
          <a:xfrm>
            <a:off x="0" y="1201389"/>
            <a:ext cx="7772400" cy="489637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A0961A1E-D78A-804B-B9B8-8F233855CA80}"/>
              </a:ext>
            </a:extLst>
          </p:cNvPr>
          <p:cNvSpPr/>
          <p:nvPr/>
        </p:nvSpPr>
        <p:spPr>
          <a:xfrm>
            <a:off x="106836" y="6108831"/>
            <a:ext cx="7863364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dirty="0">
                <a:solidFill>
                  <a:srgbClr val="000000"/>
                </a:solidFill>
                <a:latin typeface="Arial" panose="020B0604020202020204" pitchFamily="34" charset="0"/>
              </a:rPr>
              <a:t>Supplementary figure 3: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</a:rPr>
              <a:t> Contrast enhanced T1 MRI displaying contrast enhancement in the leptomeninges and subependyma 3 weeks after 100,000 DF-1 cells were injected into the pons of P7 mice. Red arrowheads indicate leptomeningeal tumor, blue arrowheads indicate subependymal tumor. </a:t>
            </a:r>
            <a:endParaRPr lang="en-US" sz="1100" dirty="0"/>
          </a:p>
        </p:txBody>
      </p:sp>
      <p:sp>
        <p:nvSpPr>
          <p:cNvPr id="6" name="Triangle 5">
            <a:extLst>
              <a:ext uri="{FF2B5EF4-FFF2-40B4-BE49-F238E27FC236}">
                <a16:creationId xmlns:a16="http://schemas.microsoft.com/office/drawing/2014/main" id="{835FD73C-0C94-7840-AA0F-305A4CA1E753}"/>
              </a:ext>
            </a:extLst>
          </p:cNvPr>
          <p:cNvSpPr/>
          <p:nvPr/>
        </p:nvSpPr>
        <p:spPr>
          <a:xfrm rot="3617269">
            <a:off x="4074185" y="5404345"/>
            <a:ext cx="56435" cy="114901"/>
          </a:xfrm>
          <a:prstGeom prst="triangle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riangle 6">
            <a:extLst>
              <a:ext uri="{FF2B5EF4-FFF2-40B4-BE49-F238E27FC236}">
                <a16:creationId xmlns:a16="http://schemas.microsoft.com/office/drawing/2014/main" id="{DE3894BF-830C-EE41-A8DE-22D9CB864A93}"/>
              </a:ext>
            </a:extLst>
          </p:cNvPr>
          <p:cNvSpPr/>
          <p:nvPr/>
        </p:nvSpPr>
        <p:spPr>
          <a:xfrm rot="3617269">
            <a:off x="2421404" y="5404347"/>
            <a:ext cx="56435" cy="114901"/>
          </a:xfrm>
          <a:prstGeom prst="triangle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riangle 7">
            <a:extLst>
              <a:ext uri="{FF2B5EF4-FFF2-40B4-BE49-F238E27FC236}">
                <a16:creationId xmlns:a16="http://schemas.microsoft.com/office/drawing/2014/main" id="{7F1669D9-13B7-1842-AF78-B8E44C7ACE65}"/>
              </a:ext>
            </a:extLst>
          </p:cNvPr>
          <p:cNvSpPr/>
          <p:nvPr/>
        </p:nvSpPr>
        <p:spPr>
          <a:xfrm rot="3617269">
            <a:off x="2542424" y="5649604"/>
            <a:ext cx="56435" cy="114901"/>
          </a:xfrm>
          <a:prstGeom prst="triangle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riangle 8">
            <a:extLst>
              <a:ext uri="{FF2B5EF4-FFF2-40B4-BE49-F238E27FC236}">
                <a16:creationId xmlns:a16="http://schemas.microsoft.com/office/drawing/2014/main" id="{7048D56E-6215-884D-9B46-1F70A79F9E79}"/>
              </a:ext>
            </a:extLst>
          </p:cNvPr>
          <p:cNvSpPr/>
          <p:nvPr/>
        </p:nvSpPr>
        <p:spPr>
          <a:xfrm rot="3617269">
            <a:off x="5706722" y="5390934"/>
            <a:ext cx="56435" cy="114901"/>
          </a:xfrm>
          <a:prstGeom prst="triangle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riangle 9">
            <a:extLst>
              <a:ext uri="{FF2B5EF4-FFF2-40B4-BE49-F238E27FC236}">
                <a16:creationId xmlns:a16="http://schemas.microsoft.com/office/drawing/2014/main" id="{F7335DA7-EAD4-CF45-A955-5D5C251D8981}"/>
              </a:ext>
            </a:extLst>
          </p:cNvPr>
          <p:cNvSpPr/>
          <p:nvPr/>
        </p:nvSpPr>
        <p:spPr>
          <a:xfrm rot="3617269">
            <a:off x="7359503" y="5404343"/>
            <a:ext cx="56435" cy="114901"/>
          </a:xfrm>
          <a:prstGeom prst="triangle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riangle 10">
            <a:extLst>
              <a:ext uri="{FF2B5EF4-FFF2-40B4-BE49-F238E27FC236}">
                <a16:creationId xmlns:a16="http://schemas.microsoft.com/office/drawing/2014/main" id="{88A4D6AF-3E35-A545-A554-36C6FAFA841F}"/>
              </a:ext>
            </a:extLst>
          </p:cNvPr>
          <p:cNvSpPr/>
          <p:nvPr/>
        </p:nvSpPr>
        <p:spPr>
          <a:xfrm rot="3617269">
            <a:off x="7319577" y="3795425"/>
            <a:ext cx="56435" cy="114901"/>
          </a:xfrm>
          <a:prstGeom prst="triangle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riangle 11">
            <a:extLst>
              <a:ext uri="{FF2B5EF4-FFF2-40B4-BE49-F238E27FC236}">
                <a16:creationId xmlns:a16="http://schemas.microsoft.com/office/drawing/2014/main" id="{1D4ED3FD-27D8-864A-BC35-B705F3B24637}"/>
              </a:ext>
            </a:extLst>
          </p:cNvPr>
          <p:cNvSpPr/>
          <p:nvPr/>
        </p:nvSpPr>
        <p:spPr>
          <a:xfrm rot="3617269">
            <a:off x="5673545" y="3826354"/>
            <a:ext cx="56435" cy="114901"/>
          </a:xfrm>
          <a:prstGeom prst="triangle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Triangle 12">
            <a:extLst>
              <a:ext uri="{FF2B5EF4-FFF2-40B4-BE49-F238E27FC236}">
                <a16:creationId xmlns:a16="http://schemas.microsoft.com/office/drawing/2014/main" id="{38437A40-4739-8A4E-B7FF-6274103E1C63}"/>
              </a:ext>
            </a:extLst>
          </p:cNvPr>
          <p:cNvSpPr/>
          <p:nvPr/>
        </p:nvSpPr>
        <p:spPr>
          <a:xfrm rot="3617269">
            <a:off x="4010301" y="3826353"/>
            <a:ext cx="56435" cy="114901"/>
          </a:xfrm>
          <a:prstGeom prst="triangle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Triangle 13">
            <a:extLst>
              <a:ext uri="{FF2B5EF4-FFF2-40B4-BE49-F238E27FC236}">
                <a16:creationId xmlns:a16="http://schemas.microsoft.com/office/drawing/2014/main" id="{C8718E18-F570-C247-8894-AFD8F234F88A}"/>
              </a:ext>
            </a:extLst>
          </p:cNvPr>
          <p:cNvSpPr/>
          <p:nvPr/>
        </p:nvSpPr>
        <p:spPr>
          <a:xfrm rot="3617269">
            <a:off x="1839940" y="3742442"/>
            <a:ext cx="56435" cy="114901"/>
          </a:xfrm>
          <a:prstGeom prst="triangle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Triangle 14">
            <a:extLst>
              <a:ext uri="{FF2B5EF4-FFF2-40B4-BE49-F238E27FC236}">
                <a16:creationId xmlns:a16="http://schemas.microsoft.com/office/drawing/2014/main" id="{99495C6C-EF9B-9D47-ACD2-57873522E56C}"/>
              </a:ext>
            </a:extLst>
          </p:cNvPr>
          <p:cNvSpPr/>
          <p:nvPr/>
        </p:nvSpPr>
        <p:spPr>
          <a:xfrm rot="10603687">
            <a:off x="3730036" y="3199762"/>
            <a:ext cx="56435" cy="114901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Triangle 15">
            <a:extLst>
              <a:ext uri="{FF2B5EF4-FFF2-40B4-BE49-F238E27FC236}">
                <a16:creationId xmlns:a16="http://schemas.microsoft.com/office/drawing/2014/main" id="{F0285A4B-C4F3-F647-BD64-45CAC45DEEC4}"/>
              </a:ext>
            </a:extLst>
          </p:cNvPr>
          <p:cNvSpPr/>
          <p:nvPr/>
        </p:nvSpPr>
        <p:spPr>
          <a:xfrm rot="11599347">
            <a:off x="4314330" y="3166582"/>
            <a:ext cx="56435" cy="114901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Triangle 16">
            <a:extLst>
              <a:ext uri="{FF2B5EF4-FFF2-40B4-BE49-F238E27FC236}">
                <a16:creationId xmlns:a16="http://schemas.microsoft.com/office/drawing/2014/main" id="{8C87FBAE-7CC5-5D46-86EB-9CAA08628458}"/>
              </a:ext>
            </a:extLst>
          </p:cNvPr>
          <p:cNvSpPr/>
          <p:nvPr/>
        </p:nvSpPr>
        <p:spPr>
          <a:xfrm rot="11485663">
            <a:off x="4493722" y="3317696"/>
            <a:ext cx="56435" cy="114901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Triangle 17">
            <a:extLst>
              <a:ext uri="{FF2B5EF4-FFF2-40B4-BE49-F238E27FC236}">
                <a16:creationId xmlns:a16="http://schemas.microsoft.com/office/drawing/2014/main" id="{58428910-045F-4F40-8F81-8FF74767ACFD}"/>
              </a:ext>
            </a:extLst>
          </p:cNvPr>
          <p:cNvSpPr/>
          <p:nvPr/>
        </p:nvSpPr>
        <p:spPr>
          <a:xfrm rot="11599347">
            <a:off x="2810013" y="3318200"/>
            <a:ext cx="56435" cy="114901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Triangle 18">
            <a:extLst>
              <a:ext uri="{FF2B5EF4-FFF2-40B4-BE49-F238E27FC236}">
                <a16:creationId xmlns:a16="http://schemas.microsoft.com/office/drawing/2014/main" id="{B7F99B12-AA99-0549-A313-CF6D35C9BDE7}"/>
              </a:ext>
            </a:extLst>
          </p:cNvPr>
          <p:cNvSpPr/>
          <p:nvPr/>
        </p:nvSpPr>
        <p:spPr>
          <a:xfrm rot="11599347">
            <a:off x="3698585" y="1901662"/>
            <a:ext cx="56435" cy="114901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Triangle 19">
            <a:extLst>
              <a:ext uri="{FF2B5EF4-FFF2-40B4-BE49-F238E27FC236}">
                <a16:creationId xmlns:a16="http://schemas.microsoft.com/office/drawing/2014/main" id="{AE14948D-096B-4943-BB4E-DD8934361B08}"/>
              </a:ext>
            </a:extLst>
          </p:cNvPr>
          <p:cNvSpPr/>
          <p:nvPr/>
        </p:nvSpPr>
        <p:spPr>
          <a:xfrm rot="11599347">
            <a:off x="5331170" y="1901661"/>
            <a:ext cx="56435" cy="114901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Triangle 20">
            <a:extLst>
              <a:ext uri="{FF2B5EF4-FFF2-40B4-BE49-F238E27FC236}">
                <a16:creationId xmlns:a16="http://schemas.microsoft.com/office/drawing/2014/main" id="{E1F03387-390D-D746-A930-ADD588088AF4}"/>
              </a:ext>
            </a:extLst>
          </p:cNvPr>
          <p:cNvSpPr/>
          <p:nvPr/>
        </p:nvSpPr>
        <p:spPr>
          <a:xfrm rot="11599347">
            <a:off x="6963754" y="1839254"/>
            <a:ext cx="56435" cy="114901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Triangle 21">
            <a:extLst>
              <a:ext uri="{FF2B5EF4-FFF2-40B4-BE49-F238E27FC236}">
                <a16:creationId xmlns:a16="http://schemas.microsoft.com/office/drawing/2014/main" id="{C2310266-AFC8-BD4B-9DE0-5C7AF908AE47}"/>
              </a:ext>
            </a:extLst>
          </p:cNvPr>
          <p:cNvSpPr/>
          <p:nvPr/>
        </p:nvSpPr>
        <p:spPr>
          <a:xfrm rot="11599347">
            <a:off x="6963753" y="3203200"/>
            <a:ext cx="56435" cy="114901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Triangle 22">
            <a:extLst>
              <a:ext uri="{FF2B5EF4-FFF2-40B4-BE49-F238E27FC236}">
                <a16:creationId xmlns:a16="http://schemas.microsoft.com/office/drawing/2014/main" id="{1094DBA5-0776-5C4D-8F1C-48F6E8EBF623}"/>
              </a:ext>
            </a:extLst>
          </p:cNvPr>
          <p:cNvSpPr/>
          <p:nvPr/>
        </p:nvSpPr>
        <p:spPr>
          <a:xfrm rot="11599347">
            <a:off x="5225956" y="3379598"/>
            <a:ext cx="56435" cy="114901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Triangle 23">
            <a:extLst>
              <a:ext uri="{FF2B5EF4-FFF2-40B4-BE49-F238E27FC236}">
                <a16:creationId xmlns:a16="http://schemas.microsoft.com/office/drawing/2014/main" id="{32B6D299-B89C-804C-ADA1-2CD449F136EA}"/>
              </a:ext>
            </a:extLst>
          </p:cNvPr>
          <p:cNvSpPr/>
          <p:nvPr/>
        </p:nvSpPr>
        <p:spPr>
          <a:xfrm rot="11599347">
            <a:off x="1974898" y="3328014"/>
            <a:ext cx="56435" cy="114901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Triangle 24">
            <a:extLst>
              <a:ext uri="{FF2B5EF4-FFF2-40B4-BE49-F238E27FC236}">
                <a16:creationId xmlns:a16="http://schemas.microsoft.com/office/drawing/2014/main" id="{687C38D1-A412-5145-A1A7-3E4433D5DD0F}"/>
              </a:ext>
            </a:extLst>
          </p:cNvPr>
          <p:cNvSpPr/>
          <p:nvPr/>
        </p:nvSpPr>
        <p:spPr>
          <a:xfrm rot="11599347">
            <a:off x="979320" y="3199760"/>
            <a:ext cx="56435" cy="114901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Triangle 25">
            <a:extLst>
              <a:ext uri="{FF2B5EF4-FFF2-40B4-BE49-F238E27FC236}">
                <a16:creationId xmlns:a16="http://schemas.microsoft.com/office/drawing/2014/main" id="{F2603D9C-C2EE-1E4C-BDE2-BA905632FF6F}"/>
              </a:ext>
            </a:extLst>
          </p:cNvPr>
          <p:cNvSpPr/>
          <p:nvPr/>
        </p:nvSpPr>
        <p:spPr>
          <a:xfrm rot="11599347">
            <a:off x="400924" y="3411457"/>
            <a:ext cx="56435" cy="114901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4480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43</Words>
  <Application>Microsoft Macintosh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n, Shelei</dc:creator>
  <cp:lastModifiedBy>Pan, Shelei</cp:lastModifiedBy>
  <cp:revision>1</cp:revision>
  <dcterms:created xsi:type="dcterms:W3CDTF">2022-02-21T16:44:36Z</dcterms:created>
  <dcterms:modified xsi:type="dcterms:W3CDTF">2022-02-21T16:46:12Z</dcterms:modified>
</cp:coreProperties>
</file>